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1227" autoAdjust="0"/>
  </p:normalViewPr>
  <p:slideViewPr>
    <p:cSldViewPr snapToGrid="0">
      <p:cViewPr varScale="1">
        <p:scale>
          <a:sx n="66" d="100"/>
          <a:sy n="66" d="100"/>
        </p:scale>
        <p:origin x="122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E90930-D338-442E-9CF2-306ED9B1DD72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AD66C7-BEF8-4885-8880-CF73458158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198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/>
              <a:t>FIGURE S1 The experimental workflow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D66C7-BEF8-4885-8880-CF734581588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4313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95D1BC-C795-4383-942D-7DDC3EF87D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8B9E5B1-9592-464A-9957-F377F4243A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E88FEB-3595-4DF8-87CB-8E8DAC22C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4DB75A-DB5E-4D4D-B03A-597E22DEF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6F90C1-056B-4D26-9092-A76264819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7483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AE6E7B-821D-4388-ABBD-E3B509ADBF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1948D9D-6EB5-4A2D-99E8-BC7A0763F6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C1B2DA-B562-4355-A3A4-4AD1AA99D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E926DC9-2262-4B39-BD89-AAD2ECDB2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1B959D-5E22-48C5-BEAD-22B2F6486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6062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C41DA33-723A-46A5-98A4-C8B6FD864C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5101F2E-AD96-46D0-AF78-A7FF3D065B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5593C3-7D41-497F-AE36-D9477EF1F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F4D93D-72A5-4C67-B3BD-5484D8164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092262-33E2-41C2-B732-BCEE019AD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1749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EC027C-9C08-4192-AF0C-16A752470E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E670CC4-F330-4C91-B73C-875EF4E7AD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8D547F-0819-4BA8-B151-2294F0AC0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34C37E-22C3-4E57-89EA-4053313FA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3D7498-7FE4-4019-9D63-EB5928597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659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53F31E-79F5-428C-8752-160BD5E5B6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1191BC3-86E9-4287-A297-9D2B4BCFC9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34D57-0189-487E-AA02-29A6EC07B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1EA85B-BE5C-4518-B1C1-BF04635CD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6AC562-AB66-4995-B6CB-BDFFE95BF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940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EB6896-D048-4D66-8DB3-3BDFBDD667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8AF0CFA-6CA0-4BEA-AABD-169D208E77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C6D0AF5-0F57-4745-AFEA-5762FE3CBA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A010769-AEAC-472C-A6CC-33A6C6F1B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24A81E-D5CC-4750-9902-38A978E6E3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4D27F05-8FB4-4DD0-8C16-8D2A57501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1056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754030-EBFE-4D90-B460-B535FD991B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701F057-FB35-4A28-95E9-1A0F9ED4B4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600300A-73B1-4533-8B31-B99377021E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6FAD29F-E9C9-495F-AABF-59EFB7522A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D438291-29EC-446B-8899-C955E7B1BB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D938099-2EBF-49E8-8731-B36C93BE2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6FC0271-4831-4EE2-994B-EC39B67A3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2D1A113-FCEB-428D-A8A5-DD0E0AB56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2878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5A5267-693D-44B6-B05B-45485F4CE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0227360-FBE4-4186-B943-BE0DBEC36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73D0717-9788-462A-8778-C7C2EFC71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B49E000-FF1A-49BF-920B-AFB229450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3237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DD88E3B-F1E0-4A4D-A1BB-AA7E95BB6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9FD3DC0-8314-43F6-819F-2C971BB0C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9E11694-F807-481A-9F05-D7995F709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5826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10212B-77EA-4D79-B8E5-A2AB75BBA3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DAAC2C9-5A29-4AAF-ACF5-0756078CE7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A68F8DF-6A82-482E-A0FE-8CD8C67B09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196D616-84AB-4146-8341-8DD5EA6FF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F17BA5-2493-4144-83A7-ECE0D1D1D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5587748-14DA-4A4A-BEC4-00F9A6E9E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515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5C1B38-9ADD-4B68-966F-AFC8B917F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8E01F50-97DA-4028-8CDF-AD61A0EC4C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97BF41B-D0EA-42AE-B657-3759262231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66929D0-3200-4540-BE05-095C982AE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4D7FEB-440B-4786-8931-FD05AF840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5218BA6-618D-4253-8057-55C5B9757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9107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961CC89-219D-41AD-B54D-DB7856BEB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F37D75A-60A4-47E9-944A-C555AE9DDB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C1C39E-A1C5-404D-ABAD-0CE342182E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84C9B5-8BF7-4FE2-9C60-42E3559A4848}" type="datetimeFigureOut">
              <a:rPr lang="zh-CN" altLang="en-US" smtClean="0"/>
              <a:t>2021/2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163CA9-EA5B-420C-90F0-55E3756794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1A4876-EE72-4AAF-96B0-B4CB9327EF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AEDAE-7637-4E77-BD35-82276C84BC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826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>
            <a:extLst>
              <a:ext uri="{FF2B5EF4-FFF2-40B4-BE49-F238E27FC236}">
                <a16:creationId xmlns:a16="http://schemas.microsoft.com/office/drawing/2014/main" id="{819E8BB3-6B38-4CC8-AA06-A3BE67A05304}"/>
              </a:ext>
            </a:extLst>
          </p:cNvPr>
          <p:cNvGrpSpPr/>
          <p:nvPr/>
        </p:nvGrpSpPr>
        <p:grpSpPr>
          <a:xfrm>
            <a:off x="200929" y="679623"/>
            <a:ext cx="11790141" cy="5498753"/>
            <a:chOff x="206145" y="421101"/>
            <a:chExt cx="11790141" cy="5498753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4FA8037C-FFE5-48B7-833C-A55BEF75E9F7}"/>
                </a:ext>
              </a:extLst>
            </p:cNvPr>
            <p:cNvSpPr txBox="1"/>
            <p:nvPr/>
          </p:nvSpPr>
          <p:spPr>
            <a:xfrm>
              <a:off x="1845084" y="421101"/>
              <a:ext cx="2954976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oiler chickens</a:t>
              </a:r>
              <a:r>
                <a: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 line 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36ED728-D9C6-4418-B14C-C64B3465DB74}"/>
                </a:ext>
              </a:extLst>
            </p:cNvPr>
            <p:cNvSpPr txBox="1"/>
            <p:nvPr/>
          </p:nvSpPr>
          <p:spPr>
            <a:xfrm>
              <a:off x="1733996" y="1220685"/>
              <a:ext cx="3177152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73 broilers from generation 5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94557AE5-2F7E-41E5-911A-4EA44865F476}"/>
                </a:ext>
              </a:extLst>
            </p:cNvPr>
            <p:cNvSpPr txBox="1"/>
            <p:nvPr/>
          </p:nvSpPr>
          <p:spPr>
            <a:xfrm>
              <a:off x="1523051" y="2201776"/>
              <a:ext cx="1592121" cy="369332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cass trait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20339D6-A9F2-4A06-AD67-20663C799C55}"/>
                </a:ext>
              </a:extLst>
            </p:cNvPr>
            <p:cNvSpPr txBox="1"/>
            <p:nvPr/>
          </p:nvSpPr>
          <p:spPr>
            <a:xfrm>
              <a:off x="3529973" y="2197300"/>
              <a:ext cx="2600876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icken 55 K SNP array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4C98C4F-F95D-4B9A-A165-7E77BD4E62AD}"/>
                </a:ext>
              </a:extLst>
            </p:cNvPr>
            <p:cNvSpPr txBox="1"/>
            <p:nvPr/>
          </p:nvSpPr>
          <p:spPr>
            <a:xfrm>
              <a:off x="6955601" y="1220685"/>
              <a:ext cx="3177152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0 broilers from generation 7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3222221-DBAC-403C-AE51-CF2D704EE1A2}"/>
                </a:ext>
              </a:extLst>
            </p:cNvPr>
            <p:cNvSpPr txBox="1"/>
            <p:nvPr/>
          </p:nvSpPr>
          <p:spPr>
            <a:xfrm>
              <a:off x="7787699" y="2829012"/>
              <a:ext cx="2601994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le-genome sequenc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6F2C7141-DF6B-42FA-BD66-E9573EC1DD43}"/>
                </a:ext>
              </a:extLst>
            </p:cNvPr>
            <p:cNvSpPr txBox="1"/>
            <p:nvPr/>
          </p:nvSpPr>
          <p:spPr>
            <a:xfrm>
              <a:off x="5497083" y="2605489"/>
              <a:ext cx="2290616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type imputation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49793465-9C25-4372-A508-B4ADD50A5A08}"/>
                </a:ext>
              </a:extLst>
            </p:cNvPr>
            <p:cNvSpPr txBox="1"/>
            <p:nvPr/>
          </p:nvSpPr>
          <p:spPr>
            <a:xfrm>
              <a:off x="3596740" y="3302393"/>
              <a:ext cx="2467342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puted genotype dat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61C906D0-45D4-443C-ABF1-29392A34D3A1}"/>
                </a:ext>
              </a:extLst>
            </p:cNvPr>
            <p:cNvSpPr txBox="1"/>
            <p:nvPr/>
          </p:nvSpPr>
          <p:spPr>
            <a:xfrm>
              <a:off x="6712013" y="3298952"/>
              <a:ext cx="3664327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sessment of imputation accuracy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914628D-A5E8-460D-9913-0611686878A4}"/>
                </a:ext>
              </a:extLst>
            </p:cNvPr>
            <p:cNvSpPr txBox="1"/>
            <p:nvPr/>
          </p:nvSpPr>
          <p:spPr>
            <a:xfrm>
              <a:off x="807871" y="4269421"/>
              <a:ext cx="5029402" cy="87357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-wide association study of carcass traits; Bayesian analysis; Estimation of SNP effect siz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F70CC7C9-2F9E-4CE3-9197-919E36AD71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19111" y="1906716"/>
              <a:ext cx="2511300" cy="12188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EF57AF5E-F973-431F-BC04-079585C2918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00060" y="578852"/>
              <a:ext cx="3744116" cy="2146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FDA4C0CD-8CCB-4AA3-ACAA-36EEF24FF5A9}"/>
                </a:ext>
              </a:extLst>
            </p:cNvPr>
            <p:cNvSpPr txBox="1"/>
            <p:nvPr/>
          </p:nvSpPr>
          <p:spPr>
            <a:xfrm>
              <a:off x="206145" y="3298952"/>
              <a:ext cx="3679591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timates of genetic parameter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28437E5D-7BD1-425B-A0F4-D1582352E43D}"/>
                </a:ext>
              </a:extLst>
            </p:cNvPr>
            <p:cNvCxnSpPr>
              <a:cxnSpLocks/>
            </p:cNvCxnSpPr>
            <p:nvPr/>
          </p:nvCxnSpPr>
          <p:spPr>
            <a:xfrm>
              <a:off x="2319111" y="3714874"/>
              <a:ext cx="0" cy="29447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87E0D134-B7AE-4501-AE9D-E0909005A333}"/>
                </a:ext>
              </a:extLst>
            </p:cNvPr>
            <p:cNvCxnSpPr>
              <a:cxnSpLocks/>
              <a:stCxn id="18" idx="2"/>
            </p:cNvCxnSpPr>
            <p:nvPr/>
          </p:nvCxnSpPr>
          <p:spPr>
            <a:xfrm>
              <a:off x="4830411" y="3671725"/>
              <a:ext cx="7673" cy="333715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CCD09098-23FC-496A-8AB9-80F3F69AF528}"/>
                </a:ext>
              </a:extLst>
            </p:cNvPr>
            <p:cNvCxnSpPr>
              <a:cxnSpLocks/>
            </p:cNvCxnSpPr>
            <p:nvPr/>
          </p:nvCxnSpPr>
          <p:spPr>
            <a:xfrm>
              <a:off x="2319111" y="4009345"/>
              <a:ext cx="2518973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直接箭头连接符 36">
              <a:extLst>
                <a:ext uri="{FF2B5EF4-FFF2-40B4-BE49-F238E27FC236}">
                  <a16:creationId xmlns:a16="http://schemas.microsoft.com/office/drawing/2014/main" id="{9B7886D0-9BB6-4554-B72B-D670556BDCA9}"/>
                </a:ext>
              </a:extLst>
            </p:cNvPr>
            <p:cNvCxnSpPr>
              <a:cxnSpLocks/>
            </p:cNvCxnSpPr>
            <p:nvPr/>
          </p:nvCxnSpPr>
          <p:spPr>
            <a:xfrm>
              <a:off x="3331429" y="4011669"/>
              <a:ext cx="0" cy="39227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BC0AAFCF-E905-4265-A8ED-D5A3C212AD24}"/>
                </a:ext>
              </a:extLst>
            </p:cNvPr>
            <p:cNvSpPr txBox="1"/>
            <p:nvPr/>
          </p:nvSpPr>
          <p:spPr>
            <a:xfrm>
              <a:off x="886468" y="5550522"/>
              <a:ext cx="6368154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>
              <a:defPPr>
                <a:defRPr lang="zh-CN"/>
              </a:defPPr>
              <a:lvl1pPr algn="ctr">
                <a:defRPr b="1"/>
              </a:lvl1pPr>
            </a:lstStyle>
            <a:p>
              <a:pPr algn="l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lective sweeps and Phylogenetic Analysis for candidate genes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接箭头连接符 9">
              <a:extLst>
                <a:ext uri="{FF2B5EF4-FFF2-40B4-BE49-F238E27FC236}">
                  <a16:creationId xmlns:a16="http://schemas.microsoft.com/office/drawing/2014/main" id="{4B8A0DC5-E0A3-4499-8C3B-026E4A3F6AC6}"/>
                </a:ext>
              </a:extLst>
            </p:cNvPr>
            <p:cNvCxnSpPr>
              <a:cxnSpLocks/>
            </p:cNvCxnSpPr>
            <p:nvPr/>
          </p:nvCxnSpPr>
          <p:spPr>
            <a:xfrm>
              <a:off x="3322572" y="5164657"/>
              <a:ext cx="0" cy="39227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0BB3D380-B4A5-4D2A-B612-713386783195}"/>
                </a:ext>
              </a:extLst>
            </p:cNvPr>
            <p:cNvSpPr txBox="1"/>
            <p:nvPr/>
          </p:nvSpPr>
          <p:spPr>
            <a:xfrm>
              <a:off x="6181105" y="4795325"/>
              <a:ext cx="5815181" cy="369332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</a:t>
              </a:r>
              <a:r>
                <a:rPr lang="en-US" altLang="zh-C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aweishan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ni chickens and 30 Camellia chicken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3E81ADC3-67EE-441E-8F18-7C42BD4AC65F}"/>
                </a:ext>
              </a:extLst>
            </p:cNvPr>
            <p:cNvSpPr txBox="1"/>
            <p:nvPr/>
          </p:nvSpPr>
          <p:spPr>
            <a:xfrm>
              <a:off x="8554608" y="5550522"/>
              <a:ext cx="2913926" cy="369332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le-genome sequence</a:t>
              </a:r>
            </a:p>
          </p:txBody>
        </p:sp>
        <p:cxnSp>
          <p:nvCxnSpPr>
            <p:cNvPr id="6" name="直接箭头连接符 5">
              <a:extLst>
                <a:ext uri="{FF2B5EF4-FFF2-40B4-BE49-F238E27FC236}">
                  <a16:creationId xmlns:a16="http://schemas.microsoft.com/office/drawing/2014/main" id="{347D7B60-A5CA-403D-A7D7-D26CBE61108E}"/>
                </a:ext>
              </a:extLst>
            </p:cNvPr>
            <p:cNvCxnSpPr>
              <a:cxnSpLocks/>
            </p:cNvCxnSpPr>
            <p:nvPr/>
          </p:nvCxnSpPr>
          <p:spPr>
            <a:xfrm>
              <a:off x="10017476" y="5223462"/>
              <a:ext cx="0" cy="39227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直接箭头连接符 6">
              <a:extLst>
                <a:ext uri="{FF2B5EF4-FFF2-40B4-BE49-F238E27FC236}">
                  <a16:creationId xmlns:a16="http://schemas.microsoft.com/office/drawing/2014/main" id="{4EB87CEA-2AD9-4677-BF0B-230778BF3ABD}"/>
                </a:ext>
              </a:extLst>
            </p:cNvPr>
            <p:cNvCxnSpPr>
              <a:stCxn id="5" idx="1"/>
              <a:endCxn id="9" idx="3"/>
            </p:cNvCxnSpPr>
            <p:nvPr/>
          </p:nvCxnSpPr>
          <p:spPr>
            <a:xfrm flipH="1">
              <a:off x="7254622" y="5735188"/>
              <a:ext cx="129998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id="{07396FDB-61FA-4BF6-89B4-435E19095576}"/>
                </a:ext>
              </a:extLst>
            </p:cNvPr>
            <p:cNvCxnSpPr>
              <a:stCxn id="11" idx="2"/>
              <a:endCxn id="12" idx="0"/>
            </p:cNvCxnSpPr>
            <p:nvPr/>
          </p:nvCxnSpPr>
          <p:spPr>
            <a:xfrm>
              <a:off x="3322572" y="790433"/>
              <a:ext cx="0" cy="430252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接箭头连接符 52">
              <a:extLst>
                <a:ext uri="{FF2B5EF4-FFF2-40B4-BE49-F238E27FC236}">
                  <a16:creationId xmlns:a16="http://schemas.microsoft.com/office/drawing/2014/main" id="{FDA67BE1-2C8D-4EF4-9B37-B2B15653DEC8}"/>
                </a:ext>
              </a:extLst>
            </p:cNvPr>
            <p:cNvCxnSpPr>
              <a:endCxn id="13" idx="0"/>
            </p:cNvCxnSpPr>
            <p:nvPr/>
          </p:nvCxnSpPr>
          <p:spPr>
            <a:xfrm>
              <a:off x="2319111" y="1918903"/>
              <a:ext cx="1" cy="282873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直接箭头连接符 58">
              <a:extLst>
                <a:ext uri="{FF2B5EF4-FFF2-40B4-BE49-F238E27FC236}">
                  <a16:creationId xmlns:a16="http://schemas.microsoft.com/office/drawing/2014/main" id="{1CF8B679-443C-4AEC-8C24-01D6187943B5}"/>
                </a:ext>
              </a:extLst>
            </p:cNvPr>
            <p:cNvCxnSpPr>
              <a:cxnSpLocks/>
              <a:endCxn id="14" idx="0"/>
            </p:cNvCxnSpPr>
            <p:nvPr/>
          </p:nvCxnSpPr>
          <p:spPr>
            <a:xfrm>
              <a:off x="4830411" y="1906716"/>
              <a:ext cx="0" cy="290584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A54647EB-8230-4703-A9A8-A291B146B9BB}"/>
                </a:ext>
              </a:extLst>
            </p:cNvPr>
            <p:cNvCxnSpPr>
              <a:stCxn id="12" idx="2"/>
            </p:cNvCxnSpPr>
            <p:nvPr/>
          </p:nvCxnSpPr>
          <p:spPr>
            <a:xfrm>
              <a:off x="3322572" y="1590017"/>
              <a:ext cx="0" cy="328886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直接箭头连接符 66">
              <a:extLst>
                <a:ext uri="{FF2B5EF4-FFF2-40B4-BE49-F238E27FC236}">
                  <a16:creationId xmlns:a16="http://schemas.microsoft.com/office/drawing/2014/main" id="{9F9CA199-8773-4F5D-93A7-2C221AB1B0E0}"/>
                </a:ext>
              </a:extLst>
            </p:cNvPr>
            <p:cNvCxnSpPr>
              <a:cxnSpLocks/>
            </p:cNvCxnSpPr>
            <p:nvPr/>
          </p:nvCxnSpPr>
          <p:spPr>
            <a:xfrm>
              <a:off x="2328134" y="2566632"/>
              <a:ext cx="0" cy="638684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直接箭头连接符 69">
              <a:extLst>
                <a:ext uri="{FF2B5EF4-FFF2-40B4-BE49-F238E27FC236}">
                  <a16:creationId xmlns:a16="http://schemas.microsoft.com/office/drawing/2014/main" id="{E8F0599A-F943-496A-A433-00586DED4CF0}"/>
                </a:ext>
              </a:extLst>
            </p:cNvPr>
            <p:cNvCxnSpPr>
              <a:cxnSpLocks/>
              <a:stCxn id="14" idx="2"/>
            </p:cNvCxnSpPr>
            <p:nvPr/>
          </p:nvCxnSpPr>
          <p:spPr>
            <a:xfrm>
              <a:off x="4830411" y="2566632"/>
              <a:ext cx="7673" cy="638684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直接箭头连接符 86">
              <a:extLst>
                <a:ext uri="{FF2B5EF4-FFF2-40B4-BE49-F238E27FC236}">
                  <a16:creationId xmlns:a16="http://schemas.microsoft.com/office/drawing/2014/main" id="{0E59171C-B9DD-449F-95E9-09B363F35CF7}"/>
                </a:ext>
              </a:extLst>
            </p:cNvPr>
            <p:cNvCxnSpPr>
              <a:cxnSpLocks/>
              <a:endCxn id="15" idx="0"/>
            </p:cNvCxnSpPr>
            <p:nvPr/>
          </p:nvCxnSpPr>
          <p:spPr>
            <a:xfrm>
              <a:off x="8544177" y="582757"/>
              <a:ext cx="0" cy="63792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直接箭头连接符 89">
              <a:extLst>
                <a:ext uri="{FF2B5EF4-FFF2-40B4-BE49-F238E27FC236}">
                  <a16:creationId xmlns:a16="http://schemas.microsoft.com/office/drawing/2014/main" id="{91FC0E8C-1991-48D8-BB04-D38CA4C98990}"/>
                </a:ext>
              </a:extLst>
            </p:cNvPr>
            <p:cNvCxnSpPr>
              <a:cxnSpLocks/>
            </p:cNvCxnSpPr>
            <p:nvPr/>
          </p:nvCxnSpPr>
          <p:spPr>
            <a:xfrm>
              <a:off x="8544177" y="1657443"/>
              <a:ext cx="0" cy="1132712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直接箭头连接符 93">
              <a:extLst>
                <a:ext uri="{FF2B5EF4-FFF2-40B4-BE49-F238E27FC236}">
                  <a16:creationId xmlns:a16="http://schemas.microsoft.com/office/drawing/2014/main" id="{F5CDFE75-E80A-4B25-932C-D17B172356B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18946" y="3026845"/>
              <a:ext cx="246875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直接箭头连接符 101">
              <a:extLst>
                <a:ext uri="{FF2B5EF4-FFF2-40B4-BE49-F238E27FC236}">
                  <a16:creationId xmlns:a16="http://schemas.microsoft.com/office/drawing/2014/main" id="{532DE2FA-5343-424E-AEB2-3C10CC0F01EC}"/>
                </a:ext>
              </a:extLst>
            </p:cNvPr>
            <p:cNvCxnSpPr>
              <a:stCxn id="18" idx="3"/>
              <a:endCxn id="19" idx="1"/>
            </p:cNvCxnSpPr>
            <p:nvPr/>
          </p:nvCxnSpPr>
          <p:spPr>
            <a:xfrm flipV="1">
              <a:off x="6064082" y="3483618"/>
              <a:ext cx="647931" cy="344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49559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77</Words>
  <Application>Microsoft Office PowerPoint</Application>
  <PresentationFormat>宽屏</PresentationFormat>
  <Paragraphs>1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li</dc:creator>
  <cp:lastModifiedBy>liuli</cp:lastModifiedBy>
  <cp:revision>7</cp:revision>
  <dcterms:created xsi:type="dcterms:W3CDTF">2020-12-17T02:29:10Z</dcterms:created>
  <dcterms:modified xsi:type="dcterms:W3CDTF">2021-02-23T12:27:01Z</dcterms:modified>
</cp:coreProperties>
</file>